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54"/>
    <p:restoredTop sz="94658"/>
  </p:normalViewPr>
  <p:slideViewPr>
    <p:cSldViewPr snapToGrid="0">
      <p:cViewPr varScale="1">
        <p:scale>
          <a:sx n="120" d="100"/>
          <a:sy n="120" d="100"/>
        </p:scale>
        <p:origin x="9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CE5007-F1F0-D851-2A58-0BE0D7B913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78342D5-1B1E-BC0F-1656-E116007D24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6C4010-C8CE-E353-41C2-3377F9A97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B28CA3-A601-5A13-C114-D81816226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BC3B55B-222D-C1AF-74DB-90C5FE05E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2484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B6EFC3-1C91-D5C5-2E13-45DE8E98A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448A0C0-5D58-E952-EE03-D7D3A3796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326212C-A2F6-8C09-AFC1-94A4E1457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2083489-ADA1-E650-A6F1-97C8149B0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5F8A73F-39AE-A666-2253-62F44BBFD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8844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5883736-CB79-AEB1-FE1A-524F088AD8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C5CC144-D2FB-C3A3-E367-34904F16CA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9A33C2A-C34A-0C27-A6E7-DD7F70B89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AE1AB8-383F-C67B-01F6-4ECA7C7F7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B6EF28-0B75-723C-535F-C585AF073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992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19CDC08-997A-2FA9-506F-DCF7E1D61D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9969056-82F9-9CAB-62D1-14121838F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A865813-2988-8AD1-59E6-36428D270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32EF076-9094-324B-FFE2-EB01206FF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ECFD86E-381A-D187-98EC-B258896D1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3528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B14D53F-32F8-C12B-40DC-8668753E1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365751D-56F1-B809-2D11-355D69D66C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8364C2-980A-C897-A526-6F709AF35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874696-FFFB-42BB-7CD3-794FEC287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BCDDD06-13A3-C33A-CB81-9141924A7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5442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9C07F8-D5DC-7F45-8B6F-3C5DACC4E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FE9E6DA-829A-92BC-7DC9-4EB090528E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7E5EBBB-42FF-029B-59C1-330509C634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F0F1DD3-4ED6-B149-9065-B33E04173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8A69444-E31F-C26B-65EE-B99AEADA3D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72F1999-65F0-26FE-6CF3-FFB0A388C2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50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1ACA9F9-4161-2245-7028-E35863412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C88F123-3B4C-5324-7EFF-D176C6C455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D451A51-BB35-686A-C230-678609AA69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6C83D40-72E8-E4B8-8FE1-E65CC99F48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0BDE2B5-1617-66A5-0FC9-E7342AC9E5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43F5F05-1739-4150-5FDC-30CB94912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76D3CA8-6258-F46A-18BD-8662340E5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70BB39A-FADE-EACD-E6DB-5557C2EAA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3942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B322D0-4DAA-C80D-AC2A-1973EB202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57176EA-9FA9-3CFD-A6E1-B5ACB8249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B688611-E8A9-955B-882C-A216142A3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B2F224B-987F-8AAE-9507-EFEDC551D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7890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67CD63E-29FF-DF42-6B3C-560ADAB11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95A9127-2A93-E2DA-D3A7-747D746DB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747F8E5-A102-03B8-EDF3-0A8B1A4E8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243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7E2599-011F-AEA0-24E5-69958718C8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0CF2680-873D-394B-6A89-BDC90D27324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EE3BD33-9EDD-4451-7498-656E2A708B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27DDF47-5BBC-32B7-7C42-980E168BB6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4949F98-CD62-58E2-8E45-106D711E2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E7D78BE-0C26-B4BE-3628-4A6017FFB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3468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B1041B1-CD30-8A18-2317-D90EDDB9D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3B482E5-5259-505E-0D52-51E7872228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B56A8EF-51F2-D7AC-6C66-EC5B65E62B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87363B1-AE28-FC1A-1C21-3C568ED90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D000E24-2BED-3CB4-72BD-5E8995682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7A7EEFD-2836-4C10-4F86-D2E6C1B5F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6797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A6DE58C-B7D2-8C82-B14B-CEF211E94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38CBB8D-B487-8666-DFC4-212E2ECFFC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06792F-E84A-38CF-1AE5-C260154D8D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C1A862-BF0A-A54B-B510-A37D83BD6F98}" type="datetimeFigureOut">
              <a:rPr lang="fr-FR" smtClean="0"/>
              <a:t>23/02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2ECD4C3-D205-B99F-7296-620AE60989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88414EC-E6CC-A479-FA79-7DA699A8E7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8A001-F3B0-494F-9E68-D97F9F17525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573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50EE6F9F-9096-1CA9-25AB-536BC55BCA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1475789"/>
              </p:ext>
            </p:extLst>
          </p:nvPr>
        </p:nvGraphicFramePr>
        <p:xfrm>
          <a:off x="200235" y="2109127"/>
          <a:ext cx="11863947" cy="25363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384843">
                  <a:extLst>
                    <a:ext uri="{9D8B030D-6E8A-4147-A177-3AD203B41FA5}">
                      <a16:colId xmlns:a16="http://schemas.microsoft.com/office/drawing/2014/main" val="3013897045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3675095637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142394308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4053348384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4254681004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949907606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2658250227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781213770"/>
                    </a:ext>
                  </a:extLst>
                </a:gridCol>
                <a:gridCol w="384843">
                  <a:extLst>
                    <a:ext uri="{9D8B030D-6E8A-4147-A177-3AD203B41FA5}">
                      <a16:colId xmlns:a16="http://schemas.microsoft.com/office/drawing/2014/main" val="4171326198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4069895966"/>
                    </a:ext>
                  </a:extLst>
                </a:gridCol>
                <a:gridCol w="432189">
                  <a:extLst>
                    <a:ext uri="{9D8B030D-6E8A-4147-A177-3AD203B41FA5}">
                      <a16:colId xmlns:a16="http://schemas.microsoft.com/office/drawing/2014/main" val="1191549719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541838459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3228695025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355633292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1627211138"/>
                    </a:ext>
                  </a:extLst>
                </a:gridCol>
                <a:gridCol w="438865">
                  <a:extLst>
                    <a:ext uri="{9D8B030D-6E8A-4147-A177-3AD203B41FA5}">
                      <a16:colId xmlns:a16="http://schemas.microsoft.com/office/drawing/2014/main" val="76435425"/>
                    </a:ext>
                  </a:extLst>
                </a:gridCol>
                <a:gridCol w="270235">
                  <a:extLst>
                    <a:ext uri="{9D8B030D-6E8A-4147-A177-3AD203B41FA5}">
                      <a16:colId xmlns:a16="http://schemas.microsoft.com/office/drawing/2014/main" val="3636763413"/>
                    </a:ext>
                  </a:extLst>
                </a:gridCol>
                <a:gridCol w="381084">
                  <a:extLst>
                    <a:ext uri="{9D8B030D-6E8A-4147-A177-3AD203B41FA5}">
                      <a16:colId xmlns:a16="http://schemas.microsoft.com/office/drawing/2014/main" val="2376366757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3215692972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3573903795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59606063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2149762956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1821644018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1415319164"/>
                    </a:ext>
                  </a:extLst>
                </a:gridCol>
                <a:gridCol w="390305">
                  <a:extLst>
                    <a:ext uri="{9D8B030D-6E8A-4147-A177-3AD203B41FA5}">
                      <a16:colId xmlns:a16="http://schemas.microsoft.com/office/drawing/2014/main" val="3967393777"/>
                    </a:ext>
                  </a:extLst>
                </a:gridCol>
                <a:gridCol w="455255">
                  <a:extLst>
                    <a:ext uri="{9D8B030D-6E8A-4147-A177-3AD203B41FA5}">
                      <a16:colId xmlns:a16="http://schemas.microsoft.com/office/drawing/2014/main" val="373915120"/>
                    </a:ext>
                  </a:extLst>
                </a:gridCol>
                <a:gridCol w="460718">
                  <a:extLst>
                    <a:ext uri="{9D8B030D-6E8A-4147-A177-3AD203B41FA5}">
                      <a16:colId xmlns:a16="http://schemas.microsoft.com/office/drawing/2014/main" val="1678510853"/>
                    </a:ext>
                  </a:extLst>
                </a:gridCol>
                <a:gridCol w="444329">
                  <a:extLst>
                    <a:ext uri="{9D8B030D-6E8A-4147-A177-3AD203B41FA5}">
                      <a16:colId xmlns:a16="http://schemas.microsoft.com/office/drawing/2014/main" val="3392051528"/>
                    </a:ext>
                  </a:extLst>
                </a:gridCol>
                <a:gridCol w="201525">
                  <a:extLst>
                    <a:ext uri="{9D8B030D-6E8A-4147-A177-3AD203B41FA5}">
                      <a16:colId xmlns:a16="http://schemas.microsoft.com/office/drawing/2014/main" val="2749730762"/>
                    </a:ext>
                  </a:extLst>
                </a:gridCol>
              </a:tblGrid>
              <a:tr h="12681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NSP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2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3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4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5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NSP6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7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8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9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0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NSP1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2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3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4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5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SP16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S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3A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ORF3B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E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M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6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7A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ORF7B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8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9B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9C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ORF10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>
                          <a:effectLst/>
                        </a:rPr>
                        <a:t>N</a:t>
                      </a:r>
                      <a:endParaRPr lang="fr-FR" sz="11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3708973"/>
                  </a:ext>
                </a:extLst>
              </a:tr>
              <a:tr h="126815"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14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43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6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2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1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0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0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0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1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0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5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0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119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6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0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1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3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2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 6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2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buNone/>
                      </a:pPr>
                      <a:r>
                        <a:rPr lang="fr-FR" sz="600" kern="100" dirty="0">
                          <a:effectLst/>
                        </a:rPr>
                        <a:t>4 </a:t>
                      </a:r>
                      <a:endParaRPr lang="fr-FR" sz="11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5934" marR="5593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6210380"/>
                  </a:ext>
                </a:extLst>
              </a:tr>
            </a:tbl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16470C74-AFA6-83C6-18DB-17FF6D144877}"/>
              </a:ext>
            </a:extLst>
          </p:cNvPr>
          <p:cNvSpPr txBox="1"/>
          <p:nvPr/>
        </p:nvSpPr>
        <p:spPr>
          <a:xfrm>
            <a:off x="200235" y="2461317"/>
            <a:ext cx="112279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idues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AL-236 and SARS-CoV-2 (Wuhan) 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8022643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87</Words>
  <Application>Microsoft Macintosh PowerPoint</Application>
  <PresentationFormat>Grand écran</PresentationFormat>
  <Paragraphs>5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nce</dc:creator>
  <cp:lastModifiedBy>Nolwenn  JOUVENET</cp:lastModifiedBy>
  <cp:revision>4</cp:revision>
  <dcterms:created xsi:type="dcterms:W3CDTF">2025-09-25T16:02:03Z</dcterms:created>
  <dcterms:modified xsi:type="dcterms:W3CDTF">2026-02-23T15:38:20Z</dcterms:modified>
</cp:coreProperties>
</file>